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269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6M/&#21453;&#36578;&#12464;&#12521;&#12501;%206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1Y/&#21453;&#36578;&#12464;&#12521;&#12501;%201Y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6M/&#21453;&#36578;&#12464;&#12521;&#12501;%206M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6M/&#21453;&#36578;&#12464;&#12521;&#12501;%206M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6M/&#21453;&#36578;&#12464;&#12521;&#12501;%206M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6M/&#21453;&#36578;&#12464;&#12521;&#12501;%206M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1Y/&#21453;&#36578;&#12464;&#12521;&#12501;%201Y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1Y/&#21453;&#36578;&#12464;&#12521;&#12501;%201Y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1Y/&#21453;&#36578;&#12464;&#12521;&#12501;%201Y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a11605c0fd7dd3d/&#12487;&#12473;&#12463;&#12488;&#12483;&#12503;/&#35542;&#25991;&#20316;&#25104;/&#35542;&#25991;WB/&#21453;&#36578;&#30011;&#20687;/1Y/&#21453;&#36578;&#12464;&#12521;&#12501;%201Y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6M.xlsx]NR1 6M'!$M$9,'[反転グラフ 6M.xlsx]NR1 6M'!$O$9</c:f>
                <c:numCache>
                  <c:formatCode>General</c:formatCode>
                  <c:ptCount val="2"/>
                  <c:pt idx="0">
                    <c:v>4.9587803752535145E-2</c:v>
                  </c:pt>
                  <c:pt idx="1">
                    <c:v>5.9046148380509193E-2</c:v>
                  </c:pt>
                </c:numCache>
              </c:numRef>
            </c:plus>
            <c:minus>
              <c:numRef>
                <c:f>'[反転グラフ 6M.xlsx]NR1 6M'!$M$9,'[反転グラフ 6M.xlsx]NR1 6M'!$O$9</c:f>
                <c:numCache>
                  <c:formatCode>General</c:formatCode>
                  <c:ptCount val="2"/>
                  <c:pt idx="0">
                    <c:v>4.9587803752535145E-2</c:v>
                  </c:pt>
                  <c:pt idx="1">
                    <c:v>5.90461483805091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6M.xlsx]NR1 6M'!$M$1,'[反転グラフ 6M.xlsx]NR1 6M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6M.xlsx]NR1 6M'!$M$3,'[反転グラフ 6M.xlsx]NR1 6M'!$O$3</c:f>
              <c:numCache>
                <c:formatCode>General</c:formatCode>
                <c:ptCount val="2"/>
                <c:pt idx="0">
                  <c:v>0.66767563227081417</c:v>
                </c:pt>
                <c:pt idx="1">
                  <c:v>0.610269735119536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C62-487D-B0FA-914B67FE7C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12721112"/>
        <c:axId val="312723072"/>
      </c:barChart>
      <c:catAx>
        <c:axId val="312721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2723072"/>
        <c:crosses val="autoZero"/>
        <c:auto val="1"/>
        <c:lblAlgn val="ctr"/>
        <c:lblOffset val="100"/>
        <c:noMultiLvlLbl val="0"/>
      </c:catAx>
      <c:valAx>
        <c:axId val="312723072"/>
        <c:scaling>
          <c:orientation val="minMax"/>
          <c:max val="0.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NR1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272111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1Y.xlsx]GluA23 1Y'!$M$9,'[反転グラフ 1Y.xlsx]GluA23 1Y'!$O$9</c:f>
                <c:numCache>
                  <c:formatCode>General</c:formatCode>
                  <c:ptCount val="2"/>
                  <c:pt idx="0">
                    <c:v>1.7707615637008366E-2</c:v>
                  </c:pt>
                  <c:pt idx="1">
                    <c:v>8.2742773918736464E-3</c:v>
                  </c:pt>
                </c:numCache>
              </c:numRef>
            </c:plus>
            <c:minus>
              <c:numRef>
                <c:f>'[反転グラフ 1Y.xlsx]GluA23 1Y'!$M$9,'[反転グラフ 1Y.xlsx]GluA23 1Y'!$O$9</c:f>
                <c:numCache>
                  <c:formatCode>General</c:formatCode>
                  <c:ptCount val="2"/>
                  <c:pt idx="0">
                    <c:v>1.7707615637008366E-2</c:v>
                  </c:pt>
                  <c:pt idx="1">
                    <c:v>8.274277391873646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1Y.xlsx]GluA23 1Y'!$M$1,'[反転グラフ 1Y.xlsx]GluA23 1Y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1Y.xlsx]GluA23 1Y'!$M$3,'[反転グラフ 1Y.xlsx]GluA23 1Y'!$O$3</c:f>
              <c:numCache>
                <c:formatCode>General</c:formatCode>
                <c:ptCount val="2"/>
                <c:pt idx="0">
                  <c:v>0.34087044627909335</c:v>
                </c:pt>
                <c:pt idx="1">
                  <c:v>0.31787887390924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CFE-4C6E-AC66-82CC36F8D2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403412640"/>
        <c:axId val="403409896"/>
      </c:barChart>
      <c:catAx>
        <c:axId val="403412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3409896"/>
        <c:crosses val="autoZero"/>
        <c:auto val="1"/>
        <c:lblAlgn val="ctr"/>
        <c:lblOffset val="100"/>
        <c:noMultiLvlLbl val="0"/>
      </c:catAx>
      <c:valAx>
        <c:axId val="403409896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GluA2/3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341264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6M.xlsx]NR2A 6M'!$M$9,'[反転グラフ 6M.xlsx]NR2A 6M'!$O$9</c:f>
                <c:numCache>
                  <c:formatCode>General</c:formatCode>
                  <c:ptCount val="2"/>
                  <c:pt idx="0">
                    <c:v>9.7440248808825011E-3</c:v>
                  </c:pt>
                  <c:pt idx="1">
                    <c:v>1.7096731483083202E-2</c:v>
                  </c:pt>
                </c:numCache>
              </c:numRef>
            </c:plus>
            <c:minus>
              <c:numRef>
                <c:f>'[反転グラフ 6M.xlsx]NR2A 6M'!$M$9,'[反転グラフ 6M.xlsx]NR2A 6M'!$O$9</c:f>
                <c:numCache>
                  <c:formatCode>General</c:formatCode>
                  <c:ptCount val="2"/>
                  <c:pt idx="0">
                    <c:v>9.7440248808825011E-3</c:v>
                  </c:pt>
                  <c:pt idx="1">
                    <c:v>1.70967314830832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6M.xlsx]NR2A 6M'!$M$1,'[反転グラフ 6M.xlsx]NR2A 6M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6M.xlsx]NR2A 6M'!$M$3,'[反転グラフ 6M.xlsx]NR2A 6M'!$O$3</c:f>
              <c:numCache>
                <c:formatCode>General</c:formatCode>
                <c:ptCount val="2"/>
                <c:pt idx="0">
                  <c:v>0.1579702403455934</c:v>
                </c:pt>
                <c:pt idx="1">
                  <c:v>0.150606295251064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9C2-4917-84EF-3E61B2A750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12724248"/>
        <c:axId val="312725424"/>
      </c:barChart>
      <c:catAx>
        <c:axId val="312724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2725424"/>
        <c:crosses val="autoZero"/>
        <c:auto val="1"/>
        <c:lblAlgn val="ctr"/>
        <c:lblOffset val="100"/>
        <c:noMultiLvlLbl val="0"/>
      </c:catAx>
      <c:valAx>
        <c:axId val="312725424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NR2A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2724248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6M.xlsx]NR2B 6M'!$M$9,'[反転グラフ 6M.xlsx]NR2B 6M'!$O$9</c:f>
                <c:numCache>
                  <c:formatCode>General</c:formatCode>
                  <c:ptCount val="2"/>
                  <c:pt idx="0">
                    <c:v>8.8706263762904931E-3</c:v>
                  </c:pt>
                  <c:pt idx="1">
                    <c:v>8.205364207796495E-3</c:v>
                  </c:pt>
                </c:numCache>
              </c:numRef>
            </c:plus>
            <c:minus>
              <c:numRef>
                <c:f>'[反転グラフ 6M.xlsx]NR2B 6M'!$M$9,'[反転グラフ 6M.xlsx]NR2B 6M'!$O$9</c:f>
                <c:numCache>
                  <c:formatCode>General</c:formatCode>
                  <c:ptCount val="2"/>
                  <c:pt idx="0">
                    <c:v>8.8706263762904931E-3</c:v>
                  </c:pt>
                  <c:pt idx="1">
                    <c:v>8.20536420779649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6M.xlsx]NR2B 6M'!$M$1,'[反転グラフ 6M.xlsx]NR2B 6M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6M.xlsx]NR2B 6M'!$M$3,'[反転グラフ 6M.xlsx]NR2B 6M'!$O$3</c:f>
              <c:numCache>
                <c:formatCode>General</c:formatCode>
                <c:ptCount val="2"/>
                <c:pt idx="0">
                  <c:v>0.12604899256542057</c:v>
                </c:pt>
                <c:pt idx="1">
                  <c:v>0.122824039454105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52E-46CE-B516-A082578337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4088"/>
        <c:axId val="399827224"/>
      </c:barChart>
      <c:catAx>
        <c:axId val="399824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7224"/>
        <c:crosses val="autoZero"/>
        <c:auto val="1"/>
        <c:lblAlgn val="ctr"/>
        <c:lblOffset val="100"/>
        <c:noMultiLvlLbl val="0"/>
      </c:catAx>
      <c:valAx>
        <c:axId val="399827224"/>
        <c:scaling>
          <c:orientation val="minMax"/>
          <c:max val="0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NR2B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4088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6M.xlsx]GluA1 6M'!$M$9,'[反転グラフ 6M.xlsx]GluA1 6M'!$O$9</c:f>
                <c:numCache>
                  <c:formatCode>General</c:formatCode>
                  <c:ptCount val="2"/>
                  <c:pt idx="0">
                    <c:v>1.9456115862172409E-2</c:v>
                  </c:pt>
                  <c:pt idx="1">
                    <c:v>1.1372967281921628E-2</c:v>
                  </c:pt>
                </c:numCache>
              </c:numRef>
            </c:plus>
            <c:minus>
              <c:numRef>
                <c:f>'[反転グラフ 6M.xlsx]GluA1 6M'!$M$9,'[反転グラフ 6M.xlsx]GluA1 6M'!$O$9</c:f>
                <c:numCache>
                  <c:formatCode>General</c:formatCode>
                  <c:ptCount val="2"/>
                  <c:pt idx="0">
                    <c:v>1.9456115862172409E-2</c:v>
                  </c:pt>
                  <c:pt idx="1">
                    <c:v>1.13729672819216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6M.xlsx]GluA1 6M'!$M$1,'[反転グラフ 6M.xlsx]GluA1 6M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6M.xlsx]GluA1 6M'!$M$3,'[反転グラフ 6M.xlsx]GluA1 6M'!$O$3</c:f>
              <c:numCache>
                <c:formatCode>General</c:formatCode>
                <c:ptCount val="2"/>
                <c:pt idx="0">
                  <c:v>0.24806611871812539</c:v>
                </c:pt>
                <c:pt idx="1">
                  <c:v>0.271937608902753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C41-4D4C-8A28-B3B245C1EC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7616"/>
        <c:axId val="399828792"/>
      </c:barChart>
      <c:catAx>
        <c:axId val="399827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8792"/>
        <c:crosses val="autoZero"/>
        <c:auto val="1"/>
        <c:lblAlgn val="ctr"/>
        <c:lblOffset val="100"/>
        <c:noMultiLvlLbl val="0"/>
      </c:catAx>
      <c:valAx>
        <c:axId val="399828792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GluA1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76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6M.xlsx]GluA23 6M'!$M$9,'[反転グラフ 6M.xlsx]GluA23 6M'!$O$9</c:f>
                <c:numCache>
                  <c:formatCode>General</c:formatCode>
                  <c:ptCount val="2"/>
                  <c:pt idx="0">
                    <c:v>1.4591976827694047E-2</c:v>
                  </c:pt>
                  <c:pt idx="1">
                    <c:v>2.5877739331059069E-2</c:v>
                  </c:pt>
                </c:numCache>
              </c:numRef>
            </c:plus>
            <c:minus>
              <c:numRef>
                <c:f>'[反転グラフ 6M.xlsx]GluA23 6M'!$M$9,'[反転グラフ 6M.xlsx]GluA23 6M'!$O$9</c:f>
                <c:numCache>
                  <c:formatCode>General</c:formatCode>
                  <c:ptCount val="2"/>
                  <c:pt idx="0">
                    <c:v>1.4591976827694047E-2</c:v>
                  </c:pt>
                  <c:pt idx="1">
                    <c:v>2.58777393310590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6M.xlsx]GluA23 6M'!$M$1,'[反転グラフ 6M.xlsx]GluA23 6M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6M.xlsx]GluA23 6M'!$M$3,'[反転グラフ 6M.xlsx]GluA23 6M'!$O$3</c:f>
              <c:numCache>
                <c:formatCode>General</c:formatCode>
                <c:ptCount val="2"/>
                <c:pt idx="0">
                  <c:v>0.35620155738119019</c:v>
                </c:pt>
                <c:pt idx="1">
                  <c:v>0.314672412946995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581-4C5E-B216-DBCE6BE01E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4480"/>
        <c:axId val="399824872"/>
      </c:barChart>
      <c:catAx>
        <c:axId val="399824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4872"/>
        <c:crosses val="autoZero"/>
        <c:auto val="1"/>
        <c:lblAlgn val="ctr"/>
        <c:lblOffset val="100"/>
        <c:noMultiLvlLbl val="0"/>
      </c:catAx>
      <c:valAx>
        <c:axId val="399824872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GluA2/3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448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1Y.xlsx]GluA1 1Y'!$M$9,'[反転グラフ 1Y.xlsx]GluA1 1Y'!$O$9</c:f>
                <c:numCache>
                  <c:formatCode>General</c:formatCode>
                  <c:ptCount val="2"/>
                  <c:pt idx="0">
                    <c:v>9.5245535222331229E-3</c:v>
                  </c:pt>
                  <c:pt idx="1">
                    <c:v>1.3042002201513346E-2</c:v>
                  </c:pt>
                </c:numCache>
              </c:numRef>
            </c:plus>
            <c:minus>
              <c:numRef>
                <c:f>'[反転グラフ 1Y.xlsx]GluA1 1Y'!$M$9,'[反転グラフ 1Y.xlsx]GluA1 1Y'!$O$9</c:f>
                <c:numCache>
                  <c:formatCode>General</c:formatCode>
                  <c:ptCount val="2"/>
                  <c:pt idx="0">
                    <c:v>9.5245535222331229E-3</c:v>
                  </c:pt>
                  <c:pt idx="1">
                    <c:v>1.304200220151334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1Y.xlsx]GluA1 1Y'!$M$1,'[反転グラフ 1Y.xlsx]GluA1 1Y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1Y.xlsx]GluA1 1Y'!$M$3,'[反転グラフ 1Y.xlsx]GluA1 1Y'!$O$3</c:f>
              <c:numCache>
                <c:formatCode>General</c:formatCode>
                <c:ptCount val="2"/>
                <c:pt idx="0">
                  <c:v>0.27389755978164354</c:v>
                </c:pt>
                <c:pt idx="1">
                  <c:v>0.272367248922735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524-4C7C-A407-599BE734A4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6048"/>
        <c:axId val="399823696"/>
      </c:barChart>
      <c:catAx>
        <c:axId val="399826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3696"/>
        <c:crosses val="autoZero"/>
        <c:auto val="1"/>
        <c:lblAlgn val="ctr"/>
        <c:lblOffset val="100"/>
        <c:noMultiLvlLbl val="0"/>
      </c:catAx>
      <c:valAx>
        <c:axId val="399823696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 dirty="0">
                    <a:solidFill>
                      <a:sysClr val="windowText" lastClr="000000"/>
                    </a:solidFill>
                  </a:rPr>
                  <a:t>GluA1/βactin ratio</a:t>
                </a:r>
              </a:p>
            </c:rich>
          </c:tx>
          <c:layout>
            <c:manualLayout>
              <c:xMode val="edge"/>
              <c:yMode val="edge"/>
              <c:x val="9.6230661040787618E-2"/>
              <c:y val="0.189805900621118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604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1Y.xlsx]NR2B 1Y'!$M$9,'[反転グラフ 1Y.xlsx]NR2B 1Y'!$O$9</c:f>
                <c:numCache>
                  <c:formatCode>General</c:formatCode>
                  <c:ptCount val="2"/>
                  <c:pt idx="0">
                    <c:v>1.0928905991389263E-2</c:v>
                  </c:pt>
                  <c:pt idx="1">
                    <c:v>1.8431552154182261E-2</c:v>
                  </c:pt>
                </c:numCache>
              </c:numRef>
            </c:plus>
            <c:minus>
              <c:numRef>
                <c:f>'[反転グラフ 1Y.xlsx]NR2B 1Y'!$M$9,'[反転グラフ 1Y.xlsx]NR2B 1Y'!$O$9</c:f>
                <c:numCache>
                  <c:formatCode>General</c:formatCode>
                  <c:ptCount val="2"/>
                  <c:pt idx="0">
                    <c:v>1.0928905991389263E-2</c:v>
                  </c:pt>
                  <c:pt idx="1">
                    <c:v>1.843155215418226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1Y.xlsx]NR2B 1Y'!$M$1,'[反転グラフ 1Y.xlsx]NR2B 1Y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1Y.xlsx]NR2B 1Y'!$M$3,'[反転グラフ 1Y.xlsx]NR2B 1Y'!$O$3</c:f>
              <c:numCache>
                <c:formatCode>General</c:formatCode>
                <c:ptCount val="2"/>
                <c:pt idx="0">
                  <c:v>0.34915612092553633</c:v>
                </c:pt>
                <c:pt idx="1">
                  <c:v>0.328612353410529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6E5-47A0-9C74-D01F89F5FD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5656"/>
        <c:axId val="399826440"/>
      </c:barChart>
      <c:catAx>
        <c:axId val="399825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6440"/>
        <c:crosses val="autoZero"/>
        <c:auto val="1"/>
        <c:lblAlgn val="ctr"/>
        <c:lblOffset val="100"/>
        <c:noMultiLvlLbl val="0"/>
      </c:catAx>
      <c:valAx>
        <c:axId val="399826440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NR2B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565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1Y.xlsx]NR2A 1Y'!$M$9,'[反転グラフ 1Y.xlsx]NR2A 1Y'!$O$9</c:f>
                <c:numCache>
                  <c:formatCode>General</c:formatCode>
                  <c:ptCount val="2"/>
                  <c:pt idx="0">
                    <c:v>1.4623455404841248E-2</c:v>
                  </c:pt>
                  <c:pt idx="1">
                    <c:v>2.172723799333617E-2</c:v>
                  </c:pt>
                </c:numCache>
              </c:numRef>
            </c:plus>
            <c:minus>
              <c:numRef>
                <c:f>'[反転グラフ 1Y.xlsx]NR2A 1Y'!$M$9,'[反転グラフ 1Y.xlsx]NR2A 1Y'!$O$9</c:f>
                <c:numCache>
                  <c:formatCode>General</c:formatCode>
                  <c:ptCount val="2"/>
                  <c:pt idx="0">
                    <c:v>1.4623455404841248E-2</c:v>
                  </c:pt>
                  <c:pt idx="1">
                    <c:v>2.17272379933361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1Y.xlsx]NR2A 1Y'!$M$1,'[反転グラフ 1Y.xlsx]NR2A 1Y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1Y.xlsx]NR2A 1Y'!$M$3,'[反転グラフ 1Y.xlsx]NR2A 1Y'!$O$3</c:f>
              <c:numCache>
                <c:formatCode>General</c:formatCode>
                <c:ptCount val="2"/>
                <c:pt idx="0">
                  <c:v>0.30389785802774172</c:v>
                </c:pt>
                <c:pt idx="1">
                  <c:v>0.306659528825565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D81-469C-8611-CBAC076EB4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6832"/>
        <c:axId val="399828400"/>
      </c:barChart>
      <c:catAx>
        <c:axId val="399826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8400"/>
        <c:crosses val="autoZero"/>
        <c:auto val="1"/>
        <c:lblAlgn val="ctr"/>
        <c:lblOffset val="100"/>
        <c:noMultiLvlLbl val="0"/>
      </c:catAx>
      <c:valAx>
        <c:axId val="399828400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NR2A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68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反転グラフ 1Y.xlsx]NR1 1Y'!$M$9,'[反転グラフ 1Y.xlsx]NR1 1Y'!$O$9</c:f>
                <c:numCache>
                  <c:formatCode>General</c:formatCode>
                  <c:ptCount val="2"/>
                  <c:pt idx="0">
                    <c:v>4.1696123856885155E-2</c:v>
                  </c:pt>
                  <c:pt idx="1">
                    <c:v>4.9026520398066716E-2</c:v>
                  </c:pt>
                </c:numCache>
              </c:numRef>
            </c:plus>
            <c:minus>
              <c:numRef>
                <c:f>'[反転グラフ 1Y.xlsx]NR1 1Y'!$M$9,'[反転グラフ 1Y.xlsx]NR1 1Y'!$O$9</c:f>
                <c:numCache>
                  <c:formatCode>General</c:formatCode>
                  <c:ptCount val="2"/>
                  <c:pt idx="0">
                    <c:v>4.1696123856885155E-2</c:v>
                  </c:pt>
                  <c:pt idx="1">
                    <c:v>4.90265203980667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反転グラフ 1Y.xlsx]NR1 1Y'!$M$1,'[反転グラフ 1Y.xlsx]NR1 1Y'!$O$1</c:f>
              <c:strCache>
                <c:ptCount val="2"/>
                <c:pt idx="0">
                  <c:v>Control</c:v>
                </c:pt>
                <c:pt idx="1">
                  <c:v>HCNP-pp KO</c:v>
                </c:pt>
              </c:strCache>
            </c:strRef>
          </c:cat>
          <c:val>
            <c:numRef>
              <c:f>'[反転グラフ 1Y.xlsx]NR1 1Y'!$M$3,'[反転グラフ 1Y.xlsx]NR1 1Y'!$O$3</c:f>
              <c:numCache>
                <c:formatCode>General</c:formatCode>
                <c:ptCount val="2"/>
                <c:pt idx="0">
                  <c:v>0.59768514985016641</c:v>
                </c:pt>
                <c:pt idx="1">
                  <c:v>0.643159399020114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DDB-4E53-BAD6-DF0071DC44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56"/>
        <c:axId val="399828008"/>
        <c:axId val="403412248"/>
      </c:barChart>
      <c:catAx>
        <c:axId val="399828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3412248"/>
        <c:crosses val="autoZero"/>
        <c:auto val="1"/>
        <c:lblAlgn val="ctr"/>
        <c:lblOffset val="100"/>
        <c:noMultiLvlLbl val="0"/>
      </c:catAx>
      <c:valAx>
        <c:axId val="403412248"/>
        <c:scaling>
          <c:orientation val="minMax"/>
          <c:max val="0.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600" b="1">
                    <a:solidFill>
                      <a:sysClr val="windowText" lastClr="000000"/>
                    </a:solidFill>
                  </a:rPr>
                  <a:t>NR1/β-actin ratio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9982800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2842"/>
            <a:ext cx="5829300" cy="313317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26842"/>
            <a:ext cx="5143500" cy="217280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1438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127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142"/>
            <a:ext cx="1478756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142"/>
            <a:ext cx="4350544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6176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9608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3638"/>
            <a:ext cx="5915025" cy="374355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22610"/>
            <a:ext cx="5915025" cy="19686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349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5710"/>
            <a:ext cx="2914650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5710"/>
            <a:ext cx="2914650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142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144"/>
            <a:ext cx="5915025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6137"/>
            <a:ext cx="2901255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87331"/>
            <a:ext cx="2901255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6137"/>
            <a:ext cx="2915543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87331"/>
            <a:ext cx="2915543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176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726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7537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5769"/>
            <a:ext cx="3471863" cy="639550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119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5769"/>
            <a:ext cx="3471863" cy="639550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913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144"/>
            <a:ext cx="591502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5710"/>
            <a:ext cx="591502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908795-885F-43E8-BA07-E3C5CA5CAC9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1240"/>
            <a:ext cx="231457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32060-DCC4-498F-8607-77C12BC37C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20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image" Target="../media/image2.png"/><Relationship Id="rId18" Type="http://schemas.openxmlformats.org/officeDocument/2006/relationships/image" Target="../media/image7.png"/><Relationship Id="rId26" Type="http://schemas.openxmlformats.org/officeDocument/2006/relationships/image" Target="../media/image15.png"/><Relationship Id="rId3" Type="http://schemas.openxmlformats.org/officeDocument/2006/relationships/chart" Target="../charts/chart2.xml"/><Relationship Id="rId21" Type="http://schemas.openxmlformats.org/officeDocument/2006/relationships/image" Target="../media/image10.png"/><Relationship Id="rId7" Type="http://schemas.openxmlformats.org/officeDocument/2006/relationships/chart" Target="../charts/chart6.xml"/><Relationship Id="rId12" Type="http://schemas.openxmlformats.org/officeDocument/2006/relationships/image" Target="../media/image1.png"/><Relationship Id="rId17" Type="http://schemas.openxmlformats.org/officeDocument/2006/relationships/image" Target="../media/image6.png"/><Relationship Id="rId25" Type="http://schemas.openxmlformats.org/officeDocument/2006/relationships/image" Target="../media/image14.png"/><Relationship Id="rId2" Type="http://schemas.openxmlformats.org/officeDocument/2006/relationships/chart" Target="../charts/chart1.xml"/><Relationship Id="rId16" Type="http://schemas.openxmlformats.org/officeDocument/2006/relationships/image" Target="../media/image5.png"/><Relationship Id="rId20" Type="http://schemas.openxmlformats.org/officeDocument/2006/relationships/image" Target="../media/image9.png"/><Relationship Id="rId29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image" Target="../media/image13.png"/><Relationship Id="rId5" Type="http://schemas.openxmlformats.org/officeDocument/2006/relationships/chart" Target="../charts/chart4.xml"/><Relationship Id="rId15" Type="http://schemas.openxmlformats.org/officeDocument/2006/relationships/image" Target="../media/image4.png"/><Relationship Id="rId23" Type="http://schemas.openxmlformats.org/officeDocument/2006/relationships/image" Target="../media/image12.png"/><Relationship Id="rId28" Type="http://schemas.openxmlformats.org/officeDocument/2006/relationships/image" Target="../media/image17.png"/><Relationship Id="rId10" Type="http://schemas.openxmlformats.org/officeDocument/2006/relationships/chart" Target="../charts/chart9.xml"/><Relationship Id="rId19" Type="http://schemas.openxmlformats.org/officeDocument/2006/relationships/image" Target="../media/image8.png"/><Relationship Id="rId31" Type="http://schemas.openxmlformats.org/officeDocument/2006/relationships/image" Target="../media/image20.png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image" Target="../media/image3.png"/><Relationship Id="rId22" Type="http://schemas.openxmlformats.org/officeDocument/2006/relationships/image" Target="../media/image11.png"/><Relationship Id="rId27" Type="http://schemas.openxmlformats.org/officeDocument/2006/relationships/image" Target="../media/image16.png"/><Relationship Id="rId30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902B6303-EC29-BD7E-04B8-CAA161438E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014731"/>
              </p:ext>
            </p:extLst>
          </p:nvPr>
        </p:nvGraphicFramePr>
        <p:xfrm>
          <a:off x="1933200" y="6318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xmlns="" id="{0E8C02EF-992D-58D2-3A2A-9CD06F2861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6964261"/>
              </p:ext>
            </p:extLst>
          </p:nvPr>
        </p:nvGraphicFramePr>
        <p:xfrm>
          <a:off x="1933200" y="16974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A5AA63AD-C12A-34A8-FA4B-25575C13DD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3071980"/>
              </p:ext>
            </p:extLst>
          </p:nvPr>
        </p:nvGraphicFramePr>
        <p:xfrm>
          <a:off x="1933200" y="27630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xmlns="" id="{31512942-E0C7-BD0C-4D8E-F65C17D5BB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8939476"/>
              </p:ext>
            </p:extLst>
          </p:nvPr>
        </p:nvGraphicFramePr>
        <p:xfrm>
          <a:off x="1933200" y="38286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xmlns="" id="{6965A9AE-1E35-EEBC-429F-403031FD7C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5240997"/>
              </p:ext>
            </p:extLst>
          </p:nvPr>
        </p:nvGraphicFramePr>
        <p:xfrm>
          <a:off x="1933200" y="48942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xmlns="" id="{F9FFF7A2-7059-5B0B-D21B-A3DD23602C39}"/>
              </a:ext>
            </a:extLst>
          </p:cNvPr>
          <p:cNvCxnSpPr>
            <a:cxnSpLocks/>
          </p:cNvCxnSpPr>
          <p:nvPr/>
        </p:nvCxnSpPr>
        <p:spPr>
          <a:xfrm>
            <a:off x="4013292" y="1241427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7C2CD0E9-91DD-1304-334A-7A25A1B7E2FF}"/>
              </a:ext>
            </a:extLst>
          </p:cNvPr>
          <p:cNvCxnSpPr>
            <a:cxnSpLocks/>
          </p:cNvCxnSpPr>
          <p:nvPr/>
        </p:nvCxnSpPr>
        <p:spPr>
          <a:xfrm>
            <a:off x="4789578" y="1241427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B0BF8A92-684E-A5FC-53F6-919D782D47EF}"/>
              </a:ext>
            </a:extLst>
          </p:cNvPr>
          <p:cNvSpPr txBox="1"/>
          <p:nvPr/>
        </p:nvSpPr>
        <p:spPr>
          <a:xfrm>
            <a:off x="3998997" y="1219946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9D50D7E1-E5BE-CD64-F080-EDC1BAB69C3F}"/>
              </a:ext>
            </a:extLst>
          </p:cNvPr>
          <p:cNvSpPr txBox="1"/>
          <p:nvPr/>
        </p:nvSpPr>
        <p:spPr>
          <a:xfrm>
            <a:off x="4654872" y="1219946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xmlns="" id="{DDA1E18A-A6FB-CA1A-DDE4-EB21C8EE1D5B}"/>
              </a:ext>
            </a:extLst>
          </p:cNvPr>
          <p:cNvCxnSpPr>
            <a:cxnSpLocks/>
          </p:cNvCxnSpPr>
          <p:nvPr/>
        </p:nvCxnSpPr>
        <p:spPr>
          <a:xfrm>
            <a:off x="4009490" y="2321824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xmlns="" id="{768669BD-5C18-5145-B7F6-C8AB307EC372}"/>
              </a:ext>
            </a:extLst>
          </p:cNvPr>
          <p:cNvCxnSpPr>
            <a:cxnSpLocks/>
          </p:cNvCxnSpPr>
          <p:nvPr/>
        </p:nvCxnSpPr>
        <p:spPr>
          <a:xfrm>
            <a:off x="4785776" y="2321824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4184F0C8-6587-A613-C4D7-FA90790F8E4C}"/>
              </a:ext>
            </a:extLst>
          </p:cNvPr>
          <p:cNvSpPr txBox="1"/>
          <p:nvPr/>
        </p:nvSpPr>
        <p:spPr>
          <a:xfrm>
            <a:off x="3995195" y="2300343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BAD7F559-146F-E871-79E8-A016B8452E5F}"/>
              </a:ext>
            </a:extLst>
          </p:cNvPr>
          <p:cNvSpPr txBox="1"/>
          <p:nvPr/>
        </p:nvSpPr>
        <p:spPr>
          <a:xfrm>
            <a:off x="4672800" y="2300343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xmlns="" id="{442AA2B1-B5C2-55B2-A4B4-E7E747189604}"/>
              </a:ext>
            </a:extLst>
          </p:cNvPr>
          <p:cNvCxnSpPr>
            <a:cxnSpLocks/>
          </p:cNvCxnSpPr>
          <p:nvPr/>
        </p:nvCxnSpPr>
        <p:spPr>
          <a:xfrm>
            <a:off x="4008806" y="3434012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xmlns="" id="{64347AFD-5745-E62D-9052-F01CC54DBFC6}"/>
              </a:ext>
            </a:extLst>
          </p:cNvPr>
          <p:cNvCxnSpPr>
            <a:cxnSpLocks/>
          </p:cNvCxnSpPr>
          <p:nvPr/>
        </p:nvCxnSpPr>
        <p:spPr>
          <a:xfrm>
            <a:off x="4785092" y="3434012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118678BF-1E94-C890-F3C8-752D77158594}"/>
              </a:ext>
            </a:extLst>
          </p:cNvPr>
          <p:cNvSpPr txBox="1"/>
          <p:nvPr/>
        </p:nvSpPr>
        <p:spPr>
          <a:xfrm>
            <a:off x="3994511" y="3405604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C762C4C7-85D4-BFC7-3275-4062DE87C7D1}"/>
              </a:ext>
            </a:extLst>
          </p:cNvPr>
          <p:cNvSpPr txBox="1"/>
          <p:nvPr/>
        </p:nvSpPr>
        <p:spPr>
          <a:xfrm>
            <a:off x="4650390" y="3405604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xmlns="" id="{E74D7476-8460-1A34-6B18-964DA0A9E583}"/>
              </a:ext>
            </a:extLst>
          </p:cNvPr>
          <p:cNvCxnSpPr>
            <a:cxnSpLocks/>
          </p:cNvCxnSpPr>
          <p:nvPr/>
        </p:nvCxnSpPr>
        <p:spPr>
          <a:xfrm>
            <a:off x="4009480" y="4450051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xmlns="" id="{1AE65157-E769-3AA6-AB60-2F8DA6618782}"/>
              </a:ext>
            </a:extLst>
          </p:cNvPr>
          <p:cNvCxnSpPr>
            <a:cxnSpLocks/>
          </p:cNvCxnSpPr>
          <p:nvPr/>
        </p:nvCxnSpPr>
        <p:spPr>
          <a:xfrm>
            <a:off x="4785766" y="4450051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5E127461-3254-7043-0F32-1CCE5F21C4E5}"/>
              </a:ext>
            </a:extLst>
          </p:cNvPr>
          <p:cNvSpPr txBox="1"/>
          <p:nvPr/>
        </p:nvSpPr>
        <p:spPr>
          <a:xfrm>
            <a:off x="3995185" y="4428570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8B29F30F-872B-CE4B-9AEA-8C100BBE7B23}"/>
              </a:ext>
            </a:extLst>
          </p:cNvPr>
          <p:cNvSpPr txBox="1"/>
          <p:nvPr/>
        </p:nvSpPr>
        <p:spPr>
          <a:xfrm>
            <a:off x="4672800" y="4428570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xmlns="" id="{9A5A655C-6CCA-8837-E8AC-1FFD89377A5B}"/>
              </a:ext>
            </a:extLst>
          </p:cNvPr>
          <p:cNvCxnSpPr>
            <a:cxnSpLocks/>
          </p:cNvCxnSpPr>
          <p:nvPr/>
        </p:nvCxnSpPr>
        <p:spPr>
          <a:xfrm>
            <a:off x="4019776" y="5511164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xmlns="" id="{8CE08FFD-721F-DF20-E498-7709E5E5AD78}"/>
              </a:ext>
            </a:extLst>
          </p:cNvPr>
          <p:cNvCxnSpPr>
            <a:cxnSpLocks/>
          </p:cNvCxnSpPr>
          <p:nvPr/>
        </p:nvCxnSpPr>
        <p:spPr>
          <a:xfrm>
            <a:off x="4796062" y="5511164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F9E63428-68A0-D56D-CDE9-9DFF8F2452C5}"/>
              </a:ext>
            </a:extLst>
          </p:cNvPr>
          <p:cNvSpPr txBox="1"/>
          <p:nvPr/>
        </p:nvSpPr>
        <p:spPr>
          <a:xfrm>
            <a:off x="4005481" y="5489683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5234370F-011F-6F12-1DC5-27E6456D61E6}"/>
              </a:ext>
            </a:extLst>
          </p:cNvPr>
          <p:cNvSpPr txBox="1"/>
          <p:nvPr/>
        </p:nvSpPr>
        <p:spPr>
          <a:xfrm>
            <a:off x="4661370" y="5489683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xmlns="" id="{3CE746FC-CBAC-17C7-209E-E61C48AE517F}"/>
              </a:ext>
            </a:extLst>
          </p:cNvPr>
          <p:cNvCxnSpPr>
            <a:cxnSpLocks/>
          </p:cNvCxnSpPr>
          <p:nvPr/>
        </p:nvCxnSpPr>
        <p:spPr>
          <a:xfrm>
            <a:off x="593220" y="1232463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xmlns="" id="{5D8616B3-1FB4-55E9-1C8C-7A4378EECDC9}"/>
              </a:ext>
            </a:extLst>
          </p:cNvPr>
          <p:cNvCxnSpPr>
            <a:cxnSpLocks/>
          </p:cNvCxnSpPr>
          <p:nvPr/>
        </p:nvCxnSpPr>
        <p:spPr>
          <a:xfrm>
            <a:off x="1369506" y="1232463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DD616871-9A85-3F21-EE6C-8739F504BF70}"/>
              </a:ext>
            </a:extLst>
          </p:cNvPr>
          <p:cNvSpPr txBox="1"/>
          <p:nvPr/>
        </p:nvSpPr>
        <p:spPr>
          <a:xfrm>
            <a:off x="578925" y="1210982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D6F9CDE2-E2C8-091C-709D-D9D7EF75E71E}"/>
              </a:ext>
            </a:extLst>
          </p:cNvPr>
          <p:cNvSpPr txBox="1"/>
          <p:nvPr/>
        </p:nvSpPr>
        <p:spPr>
          <a:xfrm>
            <a:off x="1234800" y="1210982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93289A79-5C24-B37B-D4EB-B17054510C84}"/>
              </a:ext>
            </a:extLst>
          </p:cNvPr>
          <p:cNvCxnSpPr>
            <a:cxnSpLocks/>
          </p:cNvCxnSpPr>
          <p:nvPr/>
        </p:nvCxnSpPr>
        <p:spPr>
          <a:xfrm>
            <a:off x="571490" y="2325775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xmlns="" id="{94490639-02AC-71A5-5312-5CD740DB0D14}"/>
              </a:ext>
            </a:extLst>
          </p:cNvPr>
          <p:cNvCxnSpPr>
            <a:cxnSpLocks/>
          </p:cNvCxnSpPr>
          <p:nvPr/>
        </p:nvCxnSpPr>
        <p:spPr>
          <a:xfrm>
            <a:off x="1347776" y="2325775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6AA147E0-8B0A-55AD-AC41-3B508395EBF6}"/>
              </a:ext>
            </a:extLst>
          </p:cNvPr>
          <p:cNvSpPr txBox="1"/>
          <p:nvPr/>
        </p:nvSpPr>
        <p:spPr>
          <a:xfrm>
            <a:off x="557195" y="2304294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Control</a:t>
            </a:r>
            <a:endParaRPr kumimoji="1" lang="ja-JP" altLang="en-US" sz="1000" b="1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42C9A88C-FED7-EF07-8540-AA07A167BA6A}"/>
              </a:ext>
            </a:extLst>
          </p:cNvPr>
          <p:cNvSpPr txBox="1"/>
          <p:nvPr/>
        </p:nvSpPr>
        <p:spPr>
          <a:xfrm>
            <a:off x="1234800" y="2304294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xmlns="" id="{3384F00B-7F79-A3B5-ADAB-7F2A529570F3}"/>
              </a:ext>
            </a:extLst>
          </p:cNvPr>
          <p:cNvCxnSpPr>
            <a:cxnSpLocks/>
          </p:cNvCxnSpPr>
          <p:nvPr/>
        </p:nvCxnSpPr>
        <p:spPr>
          <a:xfrm>
            <a:off x="566324" y="3391370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xmlns="" id="{D2F7BE7E-C243-DD8F-7D0D-BC67FA51DB72}"/>
              </a:ext>
            </a:extLst>
          </p:cNvPr>
          <p:cNvCxnSpPr>
            <a:cxnSpLocks/>
          </p:cNvCxnSpPr>
          <p:nvPr/>
        </p:nvCxnSpPr>
        <p:spPr>
          <a:xfrm>
            <a:off x="1342610" y="3391370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41F908C6-D2EF-A316-0F2B-88E88E34F0D8}"/>
              </a:ext>
            </a:extLst>
          </p:cNvPr>
          <p:cNvSpPr txBox="1"/>
          <p:nvPr/>
        </p:nvSpPr>
        <p:spPr>
          <a:xfrm>
            <a:off x="552029" y="3369889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Control</a:t>
            </a:r>
            <a:endParaRPr kumimoji="1" lang="ja-JP" altLang="en-US" sz="1000" b="1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F4DB1E00-3B65-BFC0-F3BE-CEF30EB2BA5B}"/>
              </a:ext>
            </a:extLst>
          </p:cNvPr>
          <p:cNvSpPr txBox="1"/>
          <p:nvPr/>
        </p:nvSpPr>
        <p:spPr>
          <a:xfrm>
            <a:off x="1207908" y="3369889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xmlns="" id="{801F1EE2-F192-7EDA-E66A-2E104CF5EFBB}"/>
              </a:ext>
            </a:extLst>
          </p:cNvPr>
          <p:cNvCxnSpPr>
            <a:cxnSpLocks/>
          </p:cNvCxnSpPr>
          <p:nvPr/>
        </p:nvCxnSpPr>
        <p:spPr>
          <a:xfrm>
            <a:off x="571480" y="4445569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xmlns="" id="{B731DA86-636A-22EC-E116-81F5FFBE5804}"/>
              </a:ext>
            </a:extLst>
          </p:cNvPr>
          <p:cNvCxnSpPr>
            <a:cxnSpLocks/>
          </p:cNvCxnSpPr>
          <p:nvPr/>
        </p:nvCxnSpPr>
        <p:spPr>
          <a:xfrm>
            <a:off x="1347766" y="4445569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6EF3B07E-6E71-0163-09F0-D2097713A62E}"/>
              </a:ext>
            </a:extLst>
          </p:cNvPr>
          <p:cNvSpPr txBox="1"/>
          <p:nvPr/>
        </p:nvSpPr>
        <p:spPr>
          <a:xfrm>
            <a:off x="557185" y="4424088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/>
              <a:t>Control</a:t>
            </a:r>
            <a:endParaRPr kumimoji="1" lang="ja-JP" altLang="en-US" sz="1000" b="1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7869B473-B8B7-9076-9087-EFB2F76B7E7F}"/>
              </a:ext>
            </a:extLst>
          </p:cNvPr>
          <p:cNvSpPr txBox="1"/>
          <p:nvPr/>
        </p:nvSpPr>
        <p:spPr>
          <a:xfrm>
            <a:off x="1234800" y="4424088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xmlns="" id="{9126ED0E-36D9-AD65-7D61-4A350123F0B0}"/>
              </a:ext>
            </a:extLst>
          </p:cNvPr>
          <p:cNvCxnSpPr>
            <a:cxnSpLocks/>
          </p:cNvCxnSpPr>
          <p:nvPr/>
        </p:nvCxnSpPr>
        <p:spPr>
          <a:xfrm>
            <a:off x="574156" y="5515646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xmlns="" id="{0791932E-6973-DBDE-AE20-C617CB105559}"/>
              </a:ext>
            </a:extLst>
          </p:cNvPr>
          <p:cNvCxnSpPr>
            <a:cxnSpLocks/>
          </p:cNvCxnSpPr>
          <p:nvPr/>
        </p:nvCxnSpPr>
        <p:spPr>
          <a:xfrm>
            <a:off x="1350442" y="5515646"/>
            <a:ext cx="62865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189412E2-AE34-DA55-AEDC-3F9E3ED91F7C}"/>
              </a:ext>
            </a:extLst>
          </p:cNvPr>
          <p:cNvSpPr txBox="1"/>
          <p:nvPr/>
        </p:nvSpPr>
        <p:spPr>
          <a:xfrm>
            <a:off x="559861" y="5494165"/>
            <a:ext cx="663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Control</a:t>
            </a:r>
            <a:endParaRPr kumimoji="1" lang="ja-JP" altLang="en-US" sz="1000" b="1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55D11637-57B2-EFD1-71B1-E7A51713C8B6}"/>
              </a:ext>
            </a:extLst>
          </p:cNvPr>
          <p:cNvSpPr txBox="1"/>
          <p:nvPr/>
        </p:nvSpPr>
        <p:spPr>
          <a:xfrm>
            <a:off x="1215750" y="5494165"/>
            <a:ext cx="860400" cy="24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HCNP-pp KO</a:t>
            </a:r>
            <a:endParaRPr kumimoji="1" lang="ja-JP" altLang="en-US" sz="1000" b="1" dirty="0"/>
          </a:p>
        </p:txBody>
      </p:sp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xmlns="" id="{51842992-3452-861A-5228-CB05656378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7056706"/>
              </p:ext>
            </p:extLst>
          </p:nvPr>
        </p:nvGraphicFramePr>
        <p:xfrm>
          <a:off x="5371200" y="38286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0" name="グラフ 49">
            <a:extLst>
              <a:ext uri="{FF2B5EF4-FFF2-40B4-BE49-F238E27FC236}">
                <a16:creationId xmlns:a16="http://schemas.microsoft.com/office/drawing/2014/main" xmlns="" id="{2B2A2952-4EE3-6639-8A29-19DBCBF489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0055182"/>
              </p:ext>
            </p:extLst>
          </p:nvPr>
        </p:nvGraphicFramePr>
        <p:xfrm>
          <a:off x="5371200" y="27630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xmlns="" id="{C4A3283C-1767-4F2E-FF10-F6EEC26C41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0078011"/>
              </p:ext>
            </p:extLst>
          </p:nvPr>
        </p:nvGraphicFramePr>
        <p:xfrm>
          <a:off x="5371200" y="16974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52" name="グラフ 51">
            <a:extLst>
              <a:ext uri="{FF2B5EF4-FFF2-40B4-BE49-F238E27FC236}">
                <a16:creationId xmlns:a16="http://schemas.microsoft.com/office/drawing/2014/main" xmlns="" id="{0F5ACD97-5CAE-2222-CE7B-E5A6873123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1563114"/>
              </p:ext>
            </p:extLst>
          </p:nvPr>
        </p:nvGraphicFramePr>
        <p:xfrm>
          <a:off x="5371200" y="6318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53" name="グラフ 52">
            <a:extLst>
              <a:ext uri="{FF2B5EF4-FFF2-40B4-BE49-F238E27FC236}">
                <a16:creationId xmlns:a16="http://schemas.microsoft.com/office/drawing/2014/main" xmlns="" id="{4570F3B4-A462-61D6-1587-CE73A09D0B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40812"/>
              </p:ext>
            </p:extLst>
          </p:nvPr>
        </p:nvGraphicFramePr>
        <p:xfrm>
          <a:off x="5371200" y="4894254"/>
          <a:ext cx="1422000" cy="115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AFF51198-70DD-F92C-4B34-E1ACE846D187}"/>
              </a:ext>
            </a:extLst>
          </p:cNvPr>
          <p:cNvSpPr txBox="1"/>
          <p:nvPr/>
        </p:nvSpPr>
        <p:spPr>
          <a:xfrm>
            <a:off x="25200" y="829926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NR1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3AD54B58-B453-14FE-2A95-BC4838C7E5D5}"/>
              </a:ext>
            </a:extLst>
          </p:cNvPr>
          <p:cNvSpPr txBox="1"/>
          <p:nvPr/>
        </p:nvSpPr>
        <p:spPr>
          <a:xfrm>
            <a:off x="25200" y="19134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NR2A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2C041C8D-1A71-9D95-0338-9D20083C3C40}"/>
              </a:ext>
            </a:extLst>
          </p:cNvPr>
          <p:cNvSpPr txBox="1"/>
          <p:nvPr/>
        </p:nvSpPr>
        <p:spPr>
          <a:xfrm>
            <a:off x="25200" y="29790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NR2B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2F53DF9F-88E2-1A39-9B6C-6B9769FA1C2F}"/>
              </a:ext>
            </a:extLst>
          </p:cNvPr>
          <p:cNvSpPr txBox="1"/>
          <p:nvPr/>
        </p:nvSpPr>
        <p:spPr>
          <a:xfrm>
            <a:off x="25200" y="40446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GluA1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67F4C009-7B1B-D136-F17E-0EEFA4BD4F65}"/>
              </a:ext>
            </a:extLst>
          </p:cNvPr>
          <p:cNvSpPr txBox="1"/>
          <p:nvPr/>
        </p:nvSpPr>
        <p:spPr>
          <a:xfrm>
            <a:off x="25199" y="5110254"/>
            <a:ext cx="553711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GluA2/3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29F1F761-CE1A-4AF1-F10B-1BC113AF7242}"/>
              </a:ext>
            </a:extLst>
          </p:cNvPr>
          <p:cNvSpPr txBox="1"/>
          <p:nvPr/>
        </p:nvSpPr>
        <p:spPr>
          <a:xfrm>
            <a:off x="3463200" y="8478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NR1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4421C43A-5148-6D14-0BC0-2BF3F994A4B6}"/>
              </a:ext>
            </a:extLst>
          </p:cNvPr>
          <p:cNvSpPr txBox="1"/>
          <p:nvPr/>
        </p:nvSpPr>
        <p:spPr>
          <a:xfrm>
            <a:off x="3463200" y="19134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NR2A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DCE4CB75-7056-73C4-5416-58DCBE7151D2}"/>
              </a:ext>
            </a:extLst>
          </p:cNvPr>
          <p:cNvSpPr txBox="1"/>
          <p:nvPr/>
        </p:nvSpPr>
        <p:spPr>
          <a:xfrm>
            <a:off x="3463200" y="29790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NR2B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6A265FAB-FA12-078E-5AA2-C5D2E26E2106}"/>
              </a:ext>
            </a:extLst>
          </p:cNvPr>
          <p:cNvSpPr txBox="1"/>
          <p:nvPr/>
        </p:nvSpPr>
        <p:spPr>
          <a:xfrm>
            <a:off x="3463200" y="4044654"/>
            <a:ext cx="509536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GluA1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571320E0-6A63-29A7-48F0-0C49FA6065F5}"/>
              </a:ext>
            </a:extLst>
          </p:cNvPr>
          <p:cNvSpPr txBox="1"/>
          <p:nvPr/>
        </p:nvSpPr>
        <p:spPr>
          <a:xfrm>
            <a:off x="3463200" y="5101290"/>
            <a:ext cx="553711" cy="4426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800" b="1" dirty="0"/>
              <a:t>GluA2/3</a:t>
            </a:r>
          </a:p>
          <a:p>
            <a:pPr>
              <a:lnSpc>
                <a:spcPct val="150000"/>
              </a:lnSpc>
            </a:pPr>
            <a:r>
              <a:rPr kumimoji="1" lang="el-GR" altLang="ja-JP" sz="800" b="1" dirty="0"/>
              <a:t>β</a:t>
            </a:r>
            <a:r>
              <a:rPr kumimoji="1" lang="en-US" altLang="ja-JP" sz="800" b="1" dirty="0"/>
              <a:t>-actin</a:t>
            </a:r>
            <a:endParaRPr kumimoji="1" lang="ja-JP" altLang="en-US" sz="800" b="1" dirty="0"/>
          </a:p>
        </p:txBody>
      </p:sp>
      <p:pic>
        <p:nvPicPr>
          <p:cNvPr id="64" name="図 63">
            <a:extLst>
              <a:ext uri="{FF2B5EF4-FFF2-40B4-BE49-F238E27FC236}">
                <a16:creationId xmlns:a16="http://schemas.microsoft.com/office/drawing/2014/main" xmlns="" id="{ED66996B-150A-90CD-5787-FF4CD106D72D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937782"/>
            <a:ext cx="1440000" cy="1017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xmlns="" id="{814AEAE5-82DE-D268-589C-94AE6099E3FF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1090890"/>
            <a:ext cx="1440000" cy="1056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xmlns="" id="{E7FB5AF5-DC85-6820-AA07-B1D4FF2053B8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2016828"/>
            <a:ext cx="1440000" cy="841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xmlns="" id="{EC79E11B-5221-C580-7923-98EE8B636408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2165454"/>
            <a:ext cx="1440000" cy="1264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xmlns="" id="{E6AD0D22-1C72-2C30-2162-59BC8FEA61C8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3073464"/>
            <a:ext cx="1440000" cy="1043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xmlns="" id="{879F14D5-24B5-5E69-6AC5-B7624D24A457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3231054"/>
            <a:ext cx="1440000" cy="1290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xmlns="" id="{2FE9EC69-E1DE-D262-7844-283B64A50CBA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4139064"/>
            <a:ext cx="1440000" cy="1123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xmlns="" id="{47A8C0BB-1878-A117-736F-89016690AE39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4296654"/>
            <a:ext cx="14400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xmlns="" id="{3323FFA3-26A8-C6DC-A929-F8F85681618A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5182254"/>
            <a:ext cx="1440000" cy="1338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図 72">
            <a:extLst>
              <a:ext uri="{FF2B5EF4-FFF2-40B4-BE49-F238E27FC236}">
                <a16:creationId xmlns:a16="http://schemas.microsoft.com/office/drawing/2014/main" xmlns="" id="{9C4E2B66-73AF-C2C4-D181-7146D97D4D7A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00" y="5362254"/>
            <a:ext cx="1440000" cy="1181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図 73">
            <a:extLst>
              <a:ext uri="{FF2B5EF4-FFF2-40B4-BE49-F238E27FC236}">
                <a16:creationId xmlns:a16="http://schemas.microsoft.com/office/drawing/2014/main" xmlns="" id="{A28A49D0-49BA-75D0-327D-0E47E62A039E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942264"/>
            <a:ext cx="1440000" cy="1041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図 74">
            <a:extLst>
              <a:ext uri="{FF2B5EF4-FFF2-40B4-BE49-F238E27FC236}">
                <a16:creationId xmlns:a16="http://schemas.microsoft.com/office/drawing/2014/main" xmlns="" id="{E2EA0A21-3C0A-7C2B-A4F0-7A768EB291EA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1099854"/>
            <a:ext cx="1440000" cy="1087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図 75">
            <a:extLst>
              <a:ext uri="{FF2B5EF4-FFF2-40B4-BE49-F238E27FC236}">
                <a16:creationId xmlns:a16="http://schemas.microsoft.com/office/drawing/2014/main" xmlns="" id="{24E54AE4-0C08-8538-C295-9F6AA11F7D0F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2021310"/>
            <a:ext cx="1440000" cy="775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図 76">
            <a:extLst>
              <a:ext uri="{FF2B5EF4-FFF2-40B4-BE49-F238E27FC236}">
                <a16:creationId xmlns:a16="http://schemas.microsoft.com/office/drawing/2014/main" xmlns="" id="{0FDAF194-34ED-4FCF-675E-EA720C7DBFB0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2165454"/>
            <a:ext cx="1440000" cy="118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図 77">
            <a:extLst>
              <a:ext uri="{FF2B5EF4-FFF2-40B4-BE49-F238E27FC236}">
                <a16:creationId xmlns:a16="http://schemas.microsoft.com/office/drawing/2014/main" xmlns="" id="{3E3A50A4-3F3C-C7E3-2683-E93047EE361F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3051054"/>
            <a:ext cx="1440000" cy="1556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xmlns="" id="{F479A0B7-0DB7-B691-DFB2-74858CC11038}"/>
              </a:ext>
            </a:extLst>
          </p:cNvPr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3231054"/>
            <a:ext cx="1440000" cy="1685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xmlns="" id="{EA105A1F-1620-AB73-1B70-C60A66C0F603}"/>
              </a:ext>
            </a:extLst>
          </p:cNvPr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4134582"/>
            <a:ext cx="1440000" cy="1121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図 80">
            <a:extLst>
              <a:ext uri="{FF2B5EF4-FFF2-40B4-BE49-F238E27FC236}">
                <a16:creationId xmlns:a16="http://schemas.microsoft.com/office/drawing/2014/main" xmlns="" id="{63FEA12A-A0C8-98FA-465A-0DCDCAEA19D0}"/>
              </a:ext>
            </a:extLst>
          </p:cNvPr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4296654"/>
            <a:ext cx="1440000" cy="1189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図 81">
            <a:extLst>
              <a:ext uri="{FF2B5EF4-FFF2-40B4-BE49-F238E27FC236}">
                <a16:creationId xmlns:a16="http://schemas.microsoft.com/office/drawing/2014/main" xmlns="" id="{80AC64F0-9FB1-33D1-F90B-2867B3184DEB}"/>
              </a:ext>
            </a:extLst>
          </p:cNvPr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5200182"/>
            <a:ext cx="1440000" cy="1098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xmlns="" id="{C1932FB3-00D1-FEF5-52E6-C6FF7AF0BBEB}"/>
              </a:ext>
            </a:extLst>
          </p:cNvPr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0" y="5362254"/>
            <a:ext cx="1440000" cy="115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3ABCB8D0-2E26-0FBF-6DA6-265040F19F26}"/>
              </a:ext>
            </a:extLst>
          </p:cNvPr>
          <p:cNvSpPr txBox="1"/>
          <p:nvPr/>
        </p:nvSpPr>
        <p:spPr>
          <a:xfrm>
            <a:off x="593206" y="578040"/>
            <a:ext cx="1383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Adult generation</a:t>
            </a:r>
            <a:endParaRPr kumimoji="1" lang="ja-JP" altLang="en-US" sz="1000" b="1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4A2B5477-4AA7-B720-54A4-F9FE8585B8E9}"/>
              </a:ext>
            </a:extLst>
          </p:cNvPr>
          <p:cNvSpPr txBox="1"/>
          <p:nvPr/>
        </p:nvSpPr>
        <p:spPr>
          <a:xfrm>
            <a:off x="4020136" y="578888"/>
            <a:ext cx="1383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Old generation</a:t>
            </a:r>
            <a:endParaRPr kumimoji="1" lang="ja-JP" altLang="en-US" sz="1000" b="1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2A53A671-00EE-9D07-27D3-5DCB44A0EB11}"/>
              </a:ext>
            </a:extLst>
          </p:cNvPr>
          <p:cNvSpPr txBox="1"/>
          <p:nvPr/>
        </p:nvSpPr>
        <p:spPr>
          <a:xfrm>
            <a:off x="190500" y="6381824"/>
            <a:ext cx="6602700" cy="24260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.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valuation of molecules related to glutamatergic synaptic function screened using western blots.</a:t>
            </a:r>
            <a:endParaRPr lang="ja-JP" altLang="ja-JP" sz="1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1, NR2A, NR2B, GluA1, GluA2/3, and PSD95 evaluated as molecules related to glutamatergic</a:t>
            </a: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ynaptic function. (left panel) The adult generation of hippocampal cholinergic 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eurostimulating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ptide-precursor protein knockout (HCNP-pp KO) mice and age-matched control mice. (right panel)</a:t>
            </a: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old generation HCNP-pp KO mice compared to the age-matched control mice. Five HCNP-pp KO</a:t>
            </a: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ce and five age-matched control mice were examined in each generation. The β-actin as internal</a:t>
            </a: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tandard in each blot was subsequently assessed on the same sheet. The data are presented as the</a:t>
            </a:r>
          </a:p>
          <a:p>
            <a:pPr marL="457200" indent="-457200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ean ± standard error of the mean.</a:t>
            </a:r>
            <a:endParaRPr lang="ja-JP" altLang="ja-JP" sz="1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6621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207</Words>
  <Application>Microsoft Office PowerPoint</Application>
  <PresentationFormat>ユーザー設定</PresentationFormat>
  <Paragraphs>6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 健悟</dc:creator>
  <cp:lastModifiedBy>Microsoft アカウント</cp:lastModifiedBy>
  <cp:revision>1</cp:revision>
  <dcterms:created xsi:type="dcterms:W3CDTF">2022-11-01T00:26:13Z</dcterms:created>
  <dcterms:modified xsi:type="dcterms:W3CDTF">2022-11-01T00:43:42Z</dcterms:modified>
</cp:coreProperties>
</file>